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82" r:id="rId2"/>
  </p:sldIdLst>
  <p:sldSz cx="9144000" cy="6858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Chakraborty, Nabarun M CTR (US)" initials="NC" lastIdx="3" clrIdx="0"/>
  <p:cmAuthor id="1" name="seid muhie" initials="sm" lastIdx="1" clrIdx="1">
    <p:extLst/>
  </p:cmAuthor>
  <p:cmAuthor id="2" name="seid muhie" initials="sm [2]" lastIdx="1" clrIdx="2">
    <p:extLst/>
  </p:cmAuthor>
  <p:cmAuthor id="3" name="seid muhie" initials="sm [3]" lastIdx="1" clrIdx="3">
    <p:extLst/>
  </p:cmAuthor>
  <p:cmAuthor id="4" name="seid muhie" initials="sm [4]" lastIdx="0" clrIdx="4">
    <p:extLst/>
  </p:cmAuthor>
  <p:cmAuthor id="5" name="seid muhie" initials="sm [5]" lastIdx="0" clrIdx="5">
    <p:extLst/>
  </p:cmAuthor>
  <p:cmAuthor id="6" name="seid muhie" initials="sm [6]" lastIdx="0" clrIdx="6">
    <p:extLst/>
  </p:cmAuthor>
  <p:cmAuthor id="7" name="seid muhie" initials="sm [7]" lastIdx="0" clrIdx="7">
    <p:extLst/>
  </p:cmAuthor>
  <p:cmAuthor id="8" name="seid muhie" initials="sm [8]" lastIdx="1" clrIdx="8">
    <p:extLst/>
  </p:cmAuthor>
  <p:cmAuthor id="9" name="seid muhie" initials="sm [9]" lastIdx="1" clrIdx="9">
    <p:extLst/>
  </p:cmAuthor>
  <p:cmAuthor id="10" name="seid muhie" initials="sm [10]" lastIdx="1" clrIdx="10">
    <p:extLst/>
  </p:cmAuthor>
  <p:cmAuthor id="11" name="seid muhie" initials="sm [11]" lastIdx="1" clrIdx="11">
    <p:extLst/>
  </p:cmAuthor>
  <p:cmAuthor id="12" name="seid muhie" initials="sm [12]" lastIdx="1" clrIdx="12">
    <p:extLst/>
  </p:cmAuthor>
  <p:cmAuthor id="13" name="seid muhie" initials="sm [13]" lastIdx="1" clrIdx="13">
    <p:extLst/>
  </p:cmAuthor>
  <p:cmAuthor id="14" name="seid muhie" initials="sm [14]" lastIdx="1" clrIdx="14">
    <p:extLst/>
  </p:cmAuthor>
  <p:cmAuthor id="15" name="seid muhie" initials="sm [15]" lastIdx="1" clrIdx="15">
    <p:extLst/>
  </p:cmAuthor>
  <p:cmAuthor id="16" name="seid muhie" initials="sm [16]" lastIdx="1" clrIdx="16">
    <p:extLst/>
  </p:cmAuthor>
  <p:cmAuthor id="17" name="seid muhie" initials="sm [17]" lastIdx="1" clrIdx="17">
    <p:extLst/>
  </p:cmAuthor>
  <p:cmAuthor id="18" name="seid muhie" initials="sm [18]" lastIdx="1" clrIdx="18">
    <p:extLst/>
  </p:cmAuthor>
  <p:cmAuthor id="19" name="Scheerer, Julia B CTR (US)" initials="SJBC(" lastIdx="2" clrIdx="19"/>
  <p:cmAuthor id="20" name="Brennan, Linda M CIV USARMY MEDCOM USACEHR (US)" initials="BLMCUMU(" lastIdx="18" clrIdx="20"/>
  <p:cmAuthor id="21" name="Kobe, MatthewCPT USARMY (US)" initials="KMU(" lastIdx="10" clrIdx="21"/>
  <p:cmAuthor id="22" name="Gautam, Aarti CTR USARMY MEDCOM USACEHR (US)" initials="GACUMU(" lastIdx="4" clrIdx="22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84E427A-3D55-4303-BF80-6455036E1DE7}" styleName="Themed Style 1 - Accent 2">
    <a:tblBg>
      <a:fillRef idx="2">
        <a:schemeClr val="accent2"/>
      </a:fillRef>
      <a:effectRef idx="1">
        <a:schemeClr val="accent2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Ref idx="1">
              <a:schemeClr val="accent2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</a:tcBdr>
        <a:fill>
          <a:solidFill>
            <a:schemeClr val="accent2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2"/>
            </a:lnRef>
          </a:left>
          <a:right>
            <a:lnRef idx="2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2">
              <a:schemeClr val="accent2"/>
            </a:lnRef>
          </a:top>
          <a:bottom>
            <a:lnRef idx="2">
              <a:schemeClr val="accent2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2"/>
          </a:solidFill>
        </a:fill>
      </a:tcStyle>
    </a:firstRow>
  </a:tblStyle>
  <a:tblStyle styleId="{3C2FFA5D-87B4-456A-9821-1D502468CF0F}" styleName="Themed Style 1 - Acc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21E4AEA4-8DFA-4A89-87EB-49C32662AFE0}" styleName="Medium Style 2 - Accent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vertBarState="minimized" horzBarState="maximized">
    <p:restoredLeft sz="18837" autoAdjust="0"/>
    <p:restoredTop sz="94660"/>
  </p:normalViewPr>
  <p:slideViewPr>
    <p:cSldViewPr>
      <p:cViewPr varScale="1">
        <p:scale>
          <a:sx n="83" d="100"/>
          <a:sy n="83" d="100"/>
        </p:scale>
        <p:origin x="-1104" y="-6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handoutMaster" Target="handoutMasters/handoutMaster1.xml"/><Relationship Id="rId9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970939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F3FBDFC4-5329-4B58-A60B-9099FF99B724}" type="datetimeFigureOut">
              <a:rPr lang="en-US" smtClean="0"/>
              <a:t>1/2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1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970939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B2AD0DD3-C6BC-41DF-AA4E-C18B20CE3D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4911086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9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04E0C714-0AE8-4168-AEB6-05EB9BB3AC8B}" type="datetimeFigureOut">
              <a:rPr lang="en-US" smtClean="0"/>
              <a:t>1/2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81100" y="696913"/>
            <a:ext cx="4648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1" y="4415790"/>
            <a:ext cx="5608320" cy="4183380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9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53E3EC81-B730-418C-99E0-577AD46B1D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254625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9FCBE0-B4CC-4557-AC09-AC1B7D72F890}" type="datetimeFigureOut">
              <a:rPr lang="en-US" smtClean="0"/>
              <a:t>1/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35A681-4678-447B-A01A-7F1540A893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80104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9FCBE0-B4CC-4557-AC09-AC1B7D72F890}" type="datetimeFigureOut">
              <a:rPr lang="en-US" smtClean="0"/>
              <a:t>1/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35A681-4678-447B-A01A-7F1540A893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72426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9FCBE0-B4CC-4557-AC09-AC1B7D72F890}" type="datetimeFigureOut">
              <a:rPr lang="en-US" smtClean="0"/>
              <a:t>1/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35A681-4678-447B-A01A-7F1540A893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56600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9FCBE0-B4CC-4557-AC09-AC1B7D72F890}" type="datetimeFigureOut">
              <a:rPr lang="en-US" smtClean="0"/>
              <a:t>1/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35A681-4678-447B-A01A-7F1540A893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18210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9FCBE0-B4CC-4557-AC09-AC1B7D72F890}" type="datetimeFigureOut">
              <a:rPr lang="en-US" smtClean="0"/>
              <a:t>1/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35A681-4678-447B-A01A-7F1540A893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92159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9FCBE0-B4CC-4557-AC09-AC1B7D72F890}" type="datetimeFigureOut">
              <a:rPr lang="en-US" smtClean="0"/>
              <a:t>1/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35A681-4678-447B-A01A-7F1540A893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13701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9FCBE0-B4CC-4557-AC09-AC1B7D72F890}" type="datetimeFigureOut">
              <a:rPr lang="en-US" smtClean="0"/>
              <a:t>1/2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35A681-4678-447B-A01A-7F1540A893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4652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9FCBE0-B4CC-4557-AC09-AC1B7D72F890}" type="datetimeFigureOut">
              <a:rPr lang="en-US" smtClean="0"/>
              <a:t>1/2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35A681-4678-447B-A01A-7F1540A893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42728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9FCBE0-B4CC-4557-AC09-AC1B7D72F890}" type="datetimeFigureOut">
              <a:rPr lang="en-US" smtClean="0"/>
              <a:t>1/2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35A681-4678-447B-A01A-7F1540A893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91615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9FCBE0-B4CC-4557-AC09-AC1B7D72F890}" type="datetimeFigureOut">
              <a:rPr lang="en-US" smtClean="0"/>
              <a:t>1/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35A681-4678-447B-A01A-7F1540A893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84252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9FCBE0-B4CC-4557-AC09-AC1B7D72F890}" type="datetimeFigureOut">
              <a:rPr lang="en-US" smtClean="0"/>
              <a:t>1/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35A681-4678-447B-A01A-7F1540A893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6584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9FCBE0-B4CC-4557-AC09-AC1B7D72F890}" type="datetimeFigureOut">
              <a:rPr lang="en-US" smtClean="0"/>
              <a:t>1/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35A681-4678-447B-A01A-7F1540A893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04882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9614" y="1464604"/>
            <a:ext cx="3868609" cy="41741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169620" y="281356"/>
            <a:ext cx="8898179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 : </a:t>
            </a:r>
            <a:r>
              <a:rPr lang="en-U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ndrograms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howing pathway clusters  in regard as to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whether metabolites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creased or decreased versus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ir matched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-0 controls: (A) early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me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oints and (B)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te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me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oints. 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228600" y="1324715"/>
            <a:ext cx="4860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) 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4386999" y="1337770"/>
            <a:ext cx="4732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24400" y="1712447"/>
            <a:ext cx="4171783" cy="36785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Rectangle 2"/>
          <p:cNvSpPr/>
          <p:nvPr/>
        </p:nvSpPr>
        <p:spPr>
          <a:xfrm>
            <a:off x="1981200" y="5334000"/>
            <a:ext cx="990600" cy="3810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Rectangle 6"/>
          <p:cNvSpPr/>
          <p:nvPr/>
        </p:nvSpPr>
        <p:spPr>
          <a:xfrm>
            <a:off x="6324600" y="5029200"/>
            <a:ext cx="1371600" cy="4953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2766139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2317</TotalTime>
  <Words>40</Words>
  <Application>Microsoft Office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MEDCOM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autam, Aarti CTR USARMY MEDCOM USACEHR (US)</dc:creator>
  <cp:lastModifiedBy>Gautam, Aarti CTR USARMY MEDCOM USACEHR (US)</cp:lastModifiedBy>
  <cp:revision>215</cp:revision>
  <cp:lastPrinted>2016-10-07T16:37:49Z</cp:lastPrinted>
  <dcterms:created xsi:type="dcterms:W3CDTF">2014-02-27T18:12:48Z</dcterms:created>
  <dcterms:modified xsi:type="dcterms:W3CDTF">2018-01-02T17:04:51Z</dcterms:modified>
</cp:coreProperties>
</file>